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1706" userDrawn="1">
          <p15:clr>
            <a:srgbClr val="A4A3A4"/>
          </p15:clr>
        </p15:guide>
        <p15:guide id="3" pos="261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824" autoAdjust="0"/>
    <p:restoredTop sz="94660"/>
  </p:normalViewPr>
  <p:slideViewPr>
    <p:cSldViewPr snapToGrid="0" showGuides="1">
      <p:cViewPr varScale="1">
        <p:scale>
          <a:sx n="47" d="100"/>
          <a:sy n="47" d="100"/>
        </p:scale>
        <p:origin x="2432" y="56"/>
      </p:cViewPr>
      <p:guideLst>
        <p:guide orient="horz" pos="3120"/>
        <p:guide pos="1706"/>
        <p:guide pos="261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92FC4-1992-4FF3-B301-173674551437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5829-0F00-4FD6-8875-FC6A036306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81290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92FC4-1992-4FF3-B301-173674551437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5829-0F00-4FD6-8875-FC6A036306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1735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92FC4-1992-4FF3-B301-173674551437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5829-0F00-4FD6-8875-FC6A036306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2261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92FC4-1992-4FF3-B301-173674551437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5829-0F00-4FD6-8875-FC6A036306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38636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92FC4-1992-4FF3-B301-173674551437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5829-0F00-4FD6-8875-FC6A036306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51354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92FC4-1992-4FF3-B301-173674551437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5829-0F00-4FD6-8875-FC6A036306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51480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92FC4-1992-4FF3-B301-173674551437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5829-0F00-4FD6-8875-FC6A036306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2300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92FC4-1992-4FF3-B301-173674551437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5829-0F00-4FD6-8875-FC6A036306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8135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92FC4-1992-4FF3-B301-173674551437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5829-0F00-4FD6-8875-FC6A036306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3245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92FC4-1992-4FF3-B301-173674551437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5829-0F00-4FD6-8875-FC6A036306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9932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592FC4-1992-4FF3-B301-173674551437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45829-0F00-4FD6-8875-FC6A036306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2274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592FC4-1992-4FF3-B301-173674551437}" type="datetimeFigureOut">
              <a:rPr lang="zh-CN" altLang="en-US" smtClean="0"/>
              <a:t>2023/3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345829-0F00-4FD6-8875-FC6A0363062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3507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8.png"/><Relationship Id="rId18" Type="http://schemas.openxmlformats.org/officeDocument/2006/relationships/image" Target="../media/image11.tif"/><Relationship Id="rId3" Type="http://schemas.openxmlformats.org/officeDocument/2006/relationships/image" Target="../media/image2.png"/><Relationship Id="rId7" Type="http://schemas.openxmlformats.org/officeDocument/2006/relationships/image" Target="../media/image4.jpg"/><Relationship Id="rId12" Type="http://schemas.openxmlformats.org/officeDocument/2006/relationships/image" Target="../media/image7.jpg"/><Relationship Id="rId17" Type="http://schemas.openxmlformats.org/officeDocument/2006/relationships/image" Target="../media/image10.tif"/><Relationship Id="rId2" Type="http://schemas.openxmlformats.org/officeDocument/2006/relationships/image" Target="../media/image1.tif"/><Relationship Id="rId16" Type="http://schemas.microsoft.com/office/2007/relationships/hdphoto" Target="../media/hdphoto6.wdp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microsoft.com/office/2007/relationships/hdphoto" Target="../media/hdphoto4.wdp"/><Relationship Id="rId5" Type="http://schemas.openxmlformats.org/officeDocument/2006/relationships/image" Target="../media/image3.png"/><Relationship Id="rId15" Type="http://schemas.openxmlformats.org/officeDocument/2006/relationships/image" Target="../media/image9.png"/><Relationship Id="rId10" Type="http://schemas.openxmlformats.org/officeDocument/2006/relationships/image" Target="../media/image6.png"/><Relationship Id="rId19" Type="http://schemas.openxmlformats.org/officeDocument/2006/relationships/image" Target="../media/image12.tif"/><Relationship Id="rId4" Type="http://schemas.microsoft.com/office/2007/relationships/hdphoto" Target="../media/hdphoto1.wdp"/><Relationship Id="rId9" Type="http://schemas.microsoft.com/office/2007/relationships/hdphoto" Target="../media/hdphoto3.wdp"/><Relationship Id="rId14" Type="http://schemas.microsoft.com/office/2007/relationships/hdphoto" Target="../media/hdphoto5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图片 44">
            <a:extLst>
              <a:ext uri="{FF2B5EF4-FFF2-40B4-BE49-F238E27FC236}">
                <a16:creationId xmlns:a16="http://schemas.microsoft.com/office/drawing/2014/main" id="{F6A59B8C-10E6-6215-2322-51A4AA84245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53" t="34826" r="43223" b="52748"/>
          <a:stretch>
            <a:fillRect/>
          </a:stretch>
        </p:blipFill>
        <p:spPr>
          <a:xfrm rot="120000">
            <a:off x="2714894" y="4462323"/>
            <a:ext cx="1240503" cy="427282"/>
          </a:xfrm>
          <a:custGeom>
            <a:avLst/>
            <a:gdLst>
              <a:gd name="connsiteX0" fmla="*/ 0 w 2024814"/>
              <a:gd name="connsiteY0" fmla="*/ 69943 h 697432"/>
              <a:gd name="connsiteX1" fmla="*/ 2002901 w 2024814"/>
              <a:gd name="connsiteY1" fmla="*/ 0 h 697432"/>
              <a:gd name="connsiteX2" fmla="*/ 2024814 w 2024814"/>
              <a:gd name="connsiteY2" fmla="*/ 627489 h 697432"/>
              <a:gd name="connsiteX3" fmla="*/ 21913 w 2024814"/>
              <a:gd name="connsiteY3" fmla="*/ 697432 h 69743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024814" h="697432">
                <a:moveTo>
                  <a:pt x="0" y="69943"/>
                </a:moveTo>
                <a:lnTo>
                  <a:pt x="2002901" y="0"/>
                </a:lnTo>
                <a:lnTo>
                  <a:pt x="2024814" y="627489"/>
                </a:lnTo>
                <a:lnTo>
                  <a:pt x="21913" y="697432"/>
                </a:lnTo>
                <a:close/>
              </a:path>
            </a:pathLst>
          </a:cu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7011290D-FF48-C6DA-E706-FEDE9A744D08}"/>
              </a:ext>
            </a:extLst>
          </p:cNvPr>
          <p:cNvSpPr txBox="1"/>
          <p:nvPr/>
        </p:nvSpPr>
        <p:spPr>
          <a:xfrm>
            <a:off x="2599457" y="345537"/>
            <a:ext cx="1452173" cy="4385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Figure 2C</a:t>
            </a:r>
          </a:p>
          <a:p>
            <a:pPr algn="ctr"/>
            <a:r>
              <a:rPr lang="en-US" altLang="zh-CN" sz="1000" dirty="0"/>
              <a:t>(A2780)</a:t>
            </a:r>
            <a:endParaRPr lang="zh-CN" altLang="en-US" sz="1000" dirty="0"/>
          </a:p>
        </p:txBody>
      </p:sp>
      <p:pic>
        <p:nvPicPr>
          <p:cNvPr id="53" name="图片 52">
            <a:extLst>
              <a:ext uri="{FF2B5EF4-FFF2-40B4-BE49-F238E27FC236}">
                <a16:creationId xmlns:a16="http://schemas.microsoft.com/office/drawing/2014/main" id="{680CB8CD-9438-5BF2-1C7C-06AFE9987EA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498" t="25395" r="58383" b="66379"/>
          <a:stretch/>
        </p:blipFill>
        <p:spPr>
          <a:xfrm>
            <a:off x="2674536" y="2188940"/>
            <a:ext cx="1287938" cy="787247"/>
          </a:xfrm>
          <a:custGeom>
            <a:avLst/>
            <a:gdLst>
              <a:gd name="connsiteX0" fmla="*/ 0 w 652670"/>
              <a:gd name="connsiteY0" fmla="*/ 0 h 198120"/>
              <a:gd name="connsiteX1" fmla="*/ 652670 w 652670"/>
              <a:gd name="connsiteY1" fmla="*/ 0 h 198120"/>
              <a:gd name="connsiteX2" fmla="*/ 652670 w 652670"/>
              <a:gd name="connsiteY2" fmla="*/ 198120 h 198120"/>
              <a:gd name="connsiteX3" fmla="*/ 0 w 652670"/>
              <a:gd name="connsiteY3" fmla="*/ 198120 h 19812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52670" h="198120">
                <a:moveTo>
                  <a:pt x="0" y="0"/>
                </a:moveTo>
                <a:lnTo>
                  <a:pt x="652670" y="0"/>
                </a:lnTo>
                <a:lnTo>
                  <a:pt x="652670" y="198120"/>
                </a:lnTo>
                <a:lnTo>
                  <a:pt x="0" y="198120"/>
                </a:lnTo>
                <a:close/>
              </a:path>
            </a:pathLst>
          </a:custGeom>
        </p:spPr>
      </p:pic>
      <p:pic>
        <p:nvPicPr>
          <p:cNvPr id="92" name="图片 91">
            <a:extLst>
              <a:ext uri="{FF2B5EF4-FFF2-40B4-BE49-F238E27FC236}">
                <a16:creationId xmlns:a16="http://schemas.microsoft.com/office/drawing/2014/main" id="{E7F2D908-4B28-3535-CD17-E8D8D618987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191" t="43471" r="50567" b="50000"/>
          <a:stretch/>
        </p:blipFill>
        <p:spPr>
          <a:xfrm>
            <a:off x="2681575" y="3003235"/>
            <a:ext cx="1287939" cy="617365"/>
          </a:xfrm>
          <a:custGeom>
            <a:avLst/>
            <a:gdLst>
              <a:gd name="connsiteX0" fmla="*/ 0 w 725756"/>
              <a:gd name="connsiteY0" fmla="*/ 0 h 195477"/>
              <a:gd name="connsiteX1" fmla="*/ 725756 w 725756"/>
              <a:gd name="connsiteY1" fmla="*/ 0 h 195477"/>
              <a:gd name="connsiteX2" fmla="*/ 725756 w 725756"/>
              <a:gd name="connsiteY2" fmla="*/ 195477 h 195477"/>
              <a:gd name="connsiteX3" fmla="*/ 0 w 725756"/>
              <a:gd name="connsiteY3" fmla="*/ 195477 h 1954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725756" h="195477">
                <a:moveTo>
                  <a:pt x="0" y="0"/>
                </a:moveTo>
                <a:lnTo>
                  <a:pt x="725756" y="0"/>
                </a:lnTo>
                <a:lnTo>
                  <a:pt x="725756" y="195477"/>
                </a:lnTo>
                <a:lnTo>
                  <a:pt x="0" y="195477"/>
                </a:lnTo>
                <a:close/>
              </a:path>
            </a:pathLst>
          </a:custGeom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id="{D079C622-D594-3195-05D8-5182F011D7B1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53" t="31697" r="44317" b="49682"/>
          <a:stretch/>
        </p:blipFill>
        <p:spPr>
          <a:xfrm>
            <a:off x="2674536" y="787942"/>
            <a:ext cx="1259591" cy="530890"/>
          </a:xfrm>
          <a:custGeom>
            <a:avLst/>
            <a:gdLst>
              <a:gd name="connsiteX0" fmla="*/ 0 w 3047817"/>
              <a:gd name="connsiteY0" fmla="*/ 0 h 511552"/>
              <a:gd name="connsiteX1" fmla="*/ 3047817 w 3047817"/>
              <a:gd name="connsiteY1" fmla="*/ 0 h 511552"/>
              <a:gd name="connsiteX2" fmla="*/ 3047817 w 3047817"/>
              <a:gd name="connsiteY2" fmla="*/ 511552 h 511552"/>
              <a:gd name="connsiteX3" fmla="*/ 0 w 3047817"/>
              <a:gd name="connsiteY3" fmla="*/ 511552 h 51155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047817" h="511552">
                <a:moveTo>
                  <a:pt x="0" y="0"/>
                </a:moveTo>
                <a:lnTo>
                  <a:pt x="3047817" y="0"/>
                </a:lnTo>
                <a:lnTo>
                  <a:pt x="3047817" y="511552"/>
                </a:lnTo>
                <a:lnTo>
                  <a:pt x="0" y="511552"/>
                </a:lnTo>
                <a:close/>
              </a:path>
            </a:pathLst>
          </a:custGeom>
        </p:spPr>
      </p:pic>
      <p:sp>
        <p:nvSpPr>
          <p:cNvPr id="64" name="文本框 63">
            <a:extLst>
              <a:ext uri="{FF2B5EF4-FFF2-40B4-BE49-F238E27FC236}">
                <a16:creationId xmlns:a16="http://schemas.microsoft.com/office/drawing/2014/main" id="{2AC9C897-7DCB-9B86-5C2C-6BA7377DFB83}"/>
              </a:ext>
            </a:extLst>
          </p:cNvPr>
          <p:cNvSpPr txBox="1"/>
          <p:nvPr/>
        </p:nvSpPr>
        <p:spPr>
          <a:xfrm>
            <a:off x="2060504" y="953296"/>
            <a:ext cx="7552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p-RIPK1</a:t>
            </a:r>
            <a:endParaRPr lang="zh-CN" altLang="en-US" sz="12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75AF574F-A8E7-5359-CD95-E27BD871E3B1}"/>
              </a:ext>
            </a:extLst>
          </p:cNvPr>
          <p:cNvSpPr txBox="1"/>
          <p:nvPr/>
        </p:nvSpPr>
        <p:spPr>
          <a:xfrm>
            <a:off x="2252786" y="2465970"/>
            <a:ext cx="5990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PARP</a:t>
            </a:r>
            <a:endParaRPr lang="zh-CN" altLang="en-US" sz="1200" dirty="0"/>
          </a:p>
        </p:txBody>
      </p:sp>
      <p:pic>
        <p:nvPicPr>
          <p:cNvPr id="81" name="图片 80">
            <a:extLst>
              <a:ext uri="{FF2B5EF4-FFF2-40B4-BE49-F238E27FC236}">
                <a16:creationId xmlns:a16="http://schemas.microsoft.com/office/drawing/2014/main" id="{5AAA1E7D-7D67-0F30-BA17-B8A6E78CF053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383" t="41797" r="50463" b="35268"/>
          <a:stretch/>
        </p:blipFill>
        <p:spPr>
          <a:xfrm>
            <a:off x="2676447" y="1357365"/>
            <a:ext cx="1259592" cy="591319"/>
          </a:xfrm>
          <a:custGeom>
            <a:avLst/>
            <a:gdLst>
              <a:gd name="connsiteX0" fmla="*/ 0 w 1702841"/>
              <a:gd name="connsiteY0" fmla="*/ 0 h 309793"/>
              <a:gd name="connsiteX1" fmla="*/ 1702841 w 1702841"/>
              <a:gd name="connsiteY1" fmla="*/ 0 h 309793"/>
              <a:gd name="connsiteX2" fmla="*/ 1702841 w 1702841"/>
              <a:gd name="connsiteY2" fmla="*/ 309793 h 309793"/>
              <a:gd name="connsiteX3" fmla="*/ 0 w 1702841"/>
              <a:gd name="connsiteY3" fmla="*/ 309793 h 3097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702841" h="309793">
                <a:moveTo>
                  <a:pt x="0" y="0"/>
                </a:moveTo>
                <a:lnTo>
                  <a:pt x="1702841" y="0"/>
                </a:lnTo>
                <a:lnTo>
                  <a:pt x="1702841" y="309793"/>
                </a:lnTo>
                <a:lnTo>
                  <a:pt x="0" y="309793"/>
                </a:lnTo>
                <a:close/>
              </a:path>
            </a:pathLst>
          </a:custGeom>
        </p:spPr>
      </p:pic>
      <p:sp>
        <p:nvSpPr>
          <p:cNvPr id="80" name="文本框 79">
            <a:extLst>
              <a:ext uri="{FF2B5EF4-FFF2-40B4-BE49-F238E27FC236}">
                <a16:creationId xmlns:a16="http://schemas.microsoft.com/office/drawing/2014/main" id="{33299951-1360-798A-D4A1-EB4D5764C4FE}"/>
              </a:ext>
            </a:extLst>
          </p:cNvPr>
          <p:cNvSpPr txBox="1"/>
          <p:nvPr/>
        </p:nvSpPr>
        <p:spPr>
          <a:xfrm>
            <a:off x="2101625" y="1532268"/>
            <a:ext cx="755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Tubulin</a:t>
            </a:r>
            <a:endParaRPr lang="zh-CN" altLang="en-US" sz="1200" dirty="0"/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9BDE7547-4BE8-09B9-69E0-25FAEB191EA1}"/>
              </a:ext>
            </a:extLst>
          </p:cNvPr>
          <p:cNvSpPr txBox="1"/>
          <p:nvPr/>
        </p:nvSpPr>
        <p:spPr>
          <a:xfrm>
            <a:off x="2613451" y="927445"/>
            <a:ext cx="6601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M</a:t>
            </a:r>
            <a:endParaRPr lang="zh-CN" altLang="en-US" sz="1200" dirty="0"/>
          </a:p>
        </p:txBody>
      </p:sp>
      <p:pic>
        <p:nvPicPr>
          <p:cNvPr id="106" name="图片 105">
            <a:extLst>
              <a:ext uri="{FF2B5EF4-FFF2-40B4-BE49-F238E27FC236}">
                <a16:creationId xmlns:a16="http://schemas.microsoft.com/office/drawing/2014/main" id="{C452A93E-D762-42F7-6288-E31D9E951E33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8456" t="35035" r="6645" b="47272"/>
          <a:stretch/>
        </p:blipFill>
        <p:spPr>
          <a:xfrm>
            <a:off x="2766765" y="6322234"/>
            <a:ext cx="1375183" cy="486721"/>
          </a:xfrm>
          <a:prstGeom prst="rect">
            <a:avLst/>
          </a:prstGeom>
        </p:spPr>
      </p:pic>
      <p:pic>
        <p:nvPicPr>
          <p:cNvPr id="101" name="图片 100">
            <a:extLst>
              <a:ext uri="{FF2B5EF4-FFF2-40B4-BE49-F238E27FC236}">
                <a16:creationId xmlns:a16="http://schemas.microsoft.com/office/drawing/2014/main" id="{FC9E1D66-88A2-D4BD-5C1C-E183AE739D71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836" t="52049" r="2319" b="31026"/>
          <a:stretch/>
        </p:blipFill>
        <p:spPr>
          <a:xfrm>
            <a:off x="2771792" y="5818777"/>
            <a:ext cx="1375182" cy="465437"/>
          </a:xfrm>
          <a:prstGeom prst="rect">
            <a:avLst/>
          </a:prstGeom>
        </p:spPr>
      </p:pic>
      <p:pic>
        <p:nvPicPr>
          <p:cNvPr id="113" name="图片 112">
            <a:extLst>
              <a:ext uri="{FF2B5EF4-FFF2-40B4-BE49-F238E27FC236}">
                <a16:creationId xmlns:a16="http://schemas.microsoft.com/office/drawing/2014/main" id="{397C8E38-A044-030A-216D-4EE61A966E65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1505" t="26272" r="49312" b="66390"/>
          <a:stretch/>
        </p:blipFill>
        <p:spPr>
          <a:xfrm>
            <a:off x="2791030" y="6874277"/>
            <a:ext cx="1375182" cy="826301"/>
          </a:xfrm>
          <a:custGeom>
            <a:avLst/>
            <a:gdLst>
              <a:gd name="connsiteX0" fmla="*/ 0 w 652670"/>
              <a:gd name="connsiteY0" fmla="*/ 0 h 198120"/>
              <a:gd name="connsiteX1" fmla="*/ 652670 w 652670"/>
              <a:gd name="connsiteY1" fmla="*/ 0 h 198120"/>
              <a:gd name="connsiteX2" fmla="*/ 652670 w 652670"/>
              <a:gd name="connsiteY2" fmla="*/ 198120 h 198120"/>
              <a:gd name="connsiteX3" fmla="*/ 0 w 652670"/>
              <a:gd name="connsiteY3" fmla="*/ 198120 h 19812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652670" h="198120">
                <a:moveTo>
                  <a:pt x="0" y="0"/>
                </a:moveTo>
                <a:lnTo>
                  <a:pt x="652670" y="0"/>
                </a:lnTo>
                <a:lnTo>
                  <a:pt x="652670" y="198120"/>
                </a:lnTo>
                <a:lnTo>
                  <a:pt x="0" y="198120"/>
                </a:lnTo>
                <a:close/>
              </a:path>
            </a:pathLst>
          </a:custGeom>
        </p:spPr>
      </p:pic>
      <p:pic>
        <p:nvPicPr>
          <p:cNvPr id="86" name="图片 85">
            <a:extLst>
              <a:ext uri="{FF2B5EF4-FFF2-40B4-BE49-F238E27FC236}">
                <a16:creationId xmlns:a16="http://schemas.microsoft.com/office/drawing/2014/main" id="{3C9CF545-0E00-6752-2F97-8BFCCB046233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158" t="43646" r="40702" b="50397"/>
          <a:stretch/>
        </p:blipFill>
        <p:spPr>
          <a:xfrm>
            <a:off x="2796110" y="7779280"/>
            <a:ext cx="1345870" cy="594452"/>
          </a:xfrm>
          <a:prstGeom prst="rect">
            <a:avLst/>
          </a:prstGeom>
        </p:spPr>
      </p:pic>
      <p:sp>
        <p:nvSpPr>
          <p:cNvPr id="94" name="文本框 93">
            <a:extLst>
              <a:ext uri="{FF2B5EF4-FFF2-40B4-BE49-F238E27FC236}">
                <a16:creationId xmlns:a16="http://schemas.microsoft.com/office/drawing/2014/main" id="{20F02A75-C715-36A9-25D6-B7B4199180AA}"/>
              </a:ext>
            </a:extLst>
          </p:cNvPr>
          <p:cNvSpPr txBox="1"/>
          <p:nvPr/>
        </p:nvSpPr>
        <p:spPr>
          <a:xfrm>
            <a:off x="2866515" y="5438858"/>
            <a:ext cx="120505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/>
              <a:t>Figure 2C</a:t>
            </a:r>
          </a:p>
          <a:p>
            <a:pPr algn="ctr"/>
            <a:r>
              <a:rPr lang="en-US" altLang="zh-CN" sz="1000" dirty="0"/>
              <a:t>(OVCA429)</a:t>
            </a:r>
            <a:endParaRPr lang="zh-CN" altLang="en-US" sz="1000" dirty="0"/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272463AE-6AD3-DB3E-6621-7621ADAC58A8}"/>
              </a:ext>
            </a:extLst>
          </p:cNvPr>
          <p:cNvSpPr txBox="1"/>
          <p:nvPr/>
        </p:nvSpPr>
        <p:spPr>
          <a:xfrm>
            <a:off x="2169960" y="5910156"/>
            <a:ext cx="7617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p-RIPK1</a:t>
            </a:r>
            <a:endParaRPr lang="zh-CN" altLang="en-US" sz="1200" dirty="0"/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00C8A45F-31A0-0C6E-BE8B-AA4886A5D52E}"/>
              </a:ext>
            </a:extLst>
          </p:cNvPr>
          <p:cNvSpPr txBox="1"/>
          <p:nvPr/>
        </p:nvSpPr>
        <p:spPr>
          <a:xfrm>
            <a:off x="2289145" y="7210436"/>
            <a:ext cx="5507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 PARP</a:t>
            </a:r>
            <a:endParaRPr lang="zh-CN" altLang="en-US" sz="1200" dirty="0"/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CC92E318-E5DA-CDF0-42D5-51B1AB465F78}"/>
              </a:ext>
            </a:extLst>
          </p:cNvPr>
          <p:cNvSpPr txBox="1"/>
          <p:nvPr/>
        </p:nvSpPr>
        <p:spPr>
          <a:xfrm>
            <a:off x="3614553" y="5826911"/>
            <a:ext cx="6601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M</a:t>
            </a:r>
            <a:endParaRPr lang="zh-CN" altLang="en-US" sz="1200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FFE2DD3F-CDD1-8A6D-0A30-171688D85F1E}"/>
              </a:ext>
            </a:extLst>
          </p:cNvPr>
          <p:cNvSpPr txBox="1"/>
          <p:nvPr/>
        </p:nvSpPr>
        <p:spPr>
          <a:xfrm>
            <a:off x="2584913" y="2145426"/>
            <a:ext cx="6601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M</a:t>
            </a:r>
            <a:endParaRPr lang="zh-CN" altLang="en-US" sz="1200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3EBA245D-35FB-5E74-8C08-1B9132CF032F}"/>
              </a:ext>
            </a:extLst>
          </p:cNvPr>
          <p:cNvSpPr txBox="1"/>
          <p:nvPr/>
        </p:nvSpPr>
        <p:spPr>
          <a:xfrm>
            <a:off x="2110321" y="3159428"/>
            <a:ext cx="755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Tubulin</a:t>
            </a:r>
            <a:endParaRPr lang="zh-CN" altLang="en-US" sz="1200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1AD7C180-2429-89F6-5D3E-B0414C3CF9F3}"/>
              </a:ext>
            </a:extLst>
          </p:cNvPr>
          <p:cNvSpPr txBox="1"/>
          <p:nvPr/>
        </p:nvSpPr>
        <p:spPr>
          <a:xfrm>
            <a:off x="2181794" y="6387134"/>
            <a:ext cx="755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Tubulin</a:t>
            </a:r>
            <a:endParaRPr lang="zh-CN" altLang="en-US" sz="1200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58FE8F27-1B32-6D23-1674-4982474201B3}"/>
              </a:ext>
            </a:extLst>
          </p:cNvPr>
          <p:cNvSpPr txBox="1"/>
          <p:nvPr/>
        </p:nvSpPr>
        <p:spPr>
          <a:xfrm>
            <a:off x="2187544" y="7970526"/>
            <a:ext cx="755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Tubulin</a:t>
            </a:r>
            <a:endParaRPr lang="zh-CN" altLang="en-US" sz="1200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0C02164-FF5E-6F63-DE61-E382449D772D}"/>
              </a:ext>
            </a:extLst>
          </p:cNvPr>
          <p:cNvSpPr txBox="1"/>
          <p:nvPr/>
        </p:nvSpPr>
        <p:spPr>
          <a:xfrm>
            <a:off x="3914931" y="6828584"/>
            <a:ext cx="6601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M</a:t>
            </a:r>
            <a:endParaRPr lang="zh-CN" altLang="en-US" sz="12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4943E011-0FE4-1DB4-D9AD-CBCA070E6CB1}"/>
              </a:ext>
            </a:extLst>
          </p:cNvPr>
          <p:cNvSpPr txBox="1"/>
          <p:nvPr/>
        </p:nvSpPr>
        <p:spPr>
          <a:xfrm>
            <a:off x="3646142" y="6304988"/>
            <a:ext cx="6601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M</a:t>
            </a:r>
            <a:endParaRPr lang="zh-CN" altLang="en-US" sz="1200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87D5C258-3D36-3914-FAB5-3D98F91AE3A6}"/>
              </a:ext>
            </a:extLst>
          </p:cNvPr>
          <p:cNvSpPr txBox="1"/>
          <p:nvPr/>
        </p:nvSpPr>
        <p:spPr>
          <a:xfrm>
            <a:off x="3892731" y="7693737"/>
            <a:ext cx="6601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M</a:t>
            </a:r>
            <a:endParaRPr lang="zh-CN" altLang="en-US" sz="1200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DF88C7F-5FE6-259C-84F5-3FF593F9557A}"/>
              </a:ext>
            </a:extLst>
          </p:cNvPr>
          <p:cNvSpPr txBox="1"/>
          <p:nvPr/>
        </p:nvSpPr>
        <p:spPr>
          <a:xfrm>
            <a:off x="2592072" y="2959815"/>
            <a:ext cx="6601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M</a:t>
            </a:r>
            <a:endParaRPr lang="zh-CN" altLang="en-US" sz="12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710D45C-B880-761E-EB84-10FE90310DFA}"/>
              </a:ext>
            </a:extLst>
          </p:cNvPr>
          <p:cNvSpPr txBox="1"/>
          <p:nvPr/>
        </p:nvSpPr>
        <p:spPr>
          <a:xfrm>
            <a:off x="2592072" y="1296235"/>
            <a:ext cx="6601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M</a:t>
            </a:r>
            <a:endParaRPr lang="zh-CN" altLang="en-US" sz="12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926ED7CE-655B-CACD-E9A8-2A8C9AEEC264}"/>
              </a:ext>
            </a:extLst>
          </p:cNvPr>
          <p:cNvSpPr txBox="1"/>
          <p:nvPr/>
        </p:nvSpPr>
        <p:spPr>
          <a:xfrm>
            <a:off x="2235430" y="4593651"/>
            <a:ext cx="5344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Actin</a:t>
            </a:r>
            <a:endParaRPr lang="zh-CN" altLang="en-US" sz="1200" dirty="0"/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F4172983-C237-7516-79DF-94F418C91F02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43" t="44487" r="33324" b="38764"/>
          <a:stretch>
            <a:fillRect/>
          </a:stretch>
        </p:blipFill>
        <p:spPr>
          <a:xfrm>
            <a:off x="2681575" y="3706376"/>
            <a:ext cx="1280899" cy="615404"/>
          </a:xfrm>
          <a:custGeom>
            <a:avLst/>
            <a:gdLst>
              <a:gd name="connsiteX0" fmla="*/ 0 w 1956831"/>
              <a:gd name="connsiteY0" fmla="*/ 0 h 940153"/>
              <a:gd name="connsiteX1" fmla="*/ 1956831 w 1956831"/>
              <a:gd name="connsiteY1" fmla="*/ 0 h 940153"/>
              <a:gd name="connsiteX2" fmla="*/ 1956831 w 1956831"/>
              <a:gd name="connsiteY2" fmla="*/ 940153 h 940153"/>
              <a:gd name="connsiteX3" fmla="*/ 0 w 1956831"/>
              <a:gd name="connsiteY3" fmla="*/ 940153 h 9401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956831" h="940153">
                <a:moveTo>
                  <a:pt x="0" y="0"/>
                </a:moveTo>
                <a:lnTo>
                  <a:pt x="1956831" y="0"/>
                </a:lnTo>
                <a:lnTo>
                  <a:pt x="1956831" y="940153"/>
                </a:lnTo>
                <a:lnTo>
                  <a:pt x="0" y="940153"/>
                </a:lnTo>
                <a:close/>
              </a:path>
            </a:pathLst>
          </a:cu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CF69E5F2-03DC-9D71-73F0-1C2FDD176335}"/>
              </a:ext>
            </a:extLst>
          </p:cNvPr>
          <p:cNvSpPr txBox="1"/>
          <p:nvPr/>
        </p:nvSpPr>
        <p:spPr>
          <a:xfrm>
            <a:off x="2169960" y="3875708"/>
            <a:ext cx="6638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RIPK1</a:t>
            </a:r>
            <a:endParaRPr lang="zh-CN" altLang="en-US" sz="1200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7EF48B1-1076-7B48-BA1E-1948FAA77056}"/>
              </a:ext>
            </a:extLst>
          </p:cNvPr>
          <p:cNvSpPr txBox="1"/>
          <p:nvPr/>
        </p:nvSpPr>
        <p:spPr>
          <a:xfrm>
            <a:off x="2719456" y="4492176"/>
            <a:ext cx="6601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M</a:t>
            </a:r>
            <a:endParaRPr lang="zh-CN" altLang="en-US" sz="1200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114DB80-12F3-AEAE-9C64-33E7316C5DDA}"/>
              </a:ext>
            </a:extLst>
          </p:cNvPr>
          <p:cNvSpPr txBox="1"/>
          <p:nvPr/>
        </p:nvSpPr>
        <p:spPr>
          <a:xfrm>
            <a:off x="2599457" y="3728410"/>
            <a:ext cx="6601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M</a:t>
            </a:r>
            <a:endParaRPr lang="zh-CN" altLang="en-US" sz="1200" dirty="0"/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B788624A-9351-1F7E-D8AA-C7AD53C5D8DA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808" t="45385" r="35987" b="39847"/>
          <a:stretch>
            <a:fillRect/>
          </a:stretch>
        </p:blipFill>
        <p:spPr>
          <a:xfrm rot="-240000">
            <a:off x="2791927" y="8997615"/>
            <a:ext cx="1306542" cy="540738"/>
          </a:xfrm>
          <a:custGeom>
            <a:avLst/>
            <a:gdLst>
              <a:gd name="connsiteX0" fmla="*/ 48409 w 2002920"/>
              <a:gd name="connsiteY0" fmla="*/ 0 h 828948"/>
              <a:gd name="connsiteX1" fmla="*/ 2002920 w 2002920"/>
              <a:gd name="connsiteY1" fmla="*/ 136673 h 828948"/>
              <a:gd name="connsiteX2" fmla="*/ 1954511 w 2002920"/>
              <a:gd name="connsiteY2" fmla="*/ 828948 h 828948"/>
              <a:gd name="connsiteX3" fmla="*/ 0 w 2002920"/>
              <a:gd name="connsiteY3" fmla="*/ 692275 h 82894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002920" h="828948">
                <a:moveTo>
                  <a:pt x="48409" y="0"/>
                </a:moveTo>
                <a:lnTo>
                  <a:pt x="2002920" y="136673"/>
                </a:lnTo>
                <a:lnTo>
                  <a:pt x="1954511" y="828948"/>
                </a:lnTo>
                <a:lnTo>
                  <a:pt x="0" y="692275"/>
                </a:lnTo>
                <a:close/>
              </a:path>
            </a:pathLst>
          </a:custGeom>
        </p:spPr>
      </p:pic>
      <p:sp>
        <p:nvSpPr>
          <p:cNvPr id="31" name="文本框 30">
            <a:extLst>
              <a:ext uri="{FF2B5EF4-FFF2-40B4-BE49-F238E27FC236}">
                <a16:creationId xmlns:a16="http://schemas.microsoft.com/office/drawing/2014/main" id="{576BE6FD-4601-9A8B-706C-65D55EC7C10B}"/>
              </a:ext>
            </a:extLst>
          </p:cNvPr>
          <p:cNvSpPr txBox="1"/>
          <p:nvPr/>
        </p:nvSpPr>
        <p:spPr>
          <a:xfrm>
            <a:off x="2303837" y="9092237"/>
            <a:ext cx="5344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Actin</a:t>
            </a:r>
            <a:endParaRPr lang="zh-CN" altLang="en-US" sz="1200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C7C01C8D-17B2-F1A5-6856-74C859D1FB45}"/>
              </a:ext>
            </a:extLst>
          </p:cNvPr>
          <p:cNvSpPr txBox="1"/>
          <p:nvPr/>
        </p:nvSpPr>
        <p:spPr>
          <a:xfrm>
            <a:off x="2303837" y="8534960"/>
            <a:ext cx="5866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RIPK1</a:t>
            </a:r>
            <a:endParaRPr lang="zh-CN" altLang="en-US" sz="1200" dirty="0"/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C449E7C9-3B70-FFAE-EC9D-083AEF98BEFA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37" t="44224" r="34815" b="41289"/>
          <a:stretch>
            <a:fillRect/>
          </a:stretch>
        </p:blipFill>
        <p:spPr>
          <a:xfrm rot="-300000">
            <a:off x="2788487" y="8423091"/>
            <a:ext cx="1367413" cy="558195"/>
          </a:xfrm>
          <a:custGeom>
            <a:avLst/>
            <a:gdLst>
              <a:gd name="connsiteX0" fmla="*/ 56329 w 1992076"/>
              <a:gd name="connsiteY0" fmla="*/ 0 h 813190"/>
              <a:gd name="connsiteX1" fmla="*/ 1992076 w 1992076"/>
              <a:gd name="connsiteY1" fmla="*/ 169356 h 813190"/>
              <a:gd name="connsiteX2" fmla="*/ 1935748 w 1992076"/>
              <a:gd name="connsiteY2" fmla="*/ 813190 h 813190"/>
              <a:gd name="connsiteX3" fmla="*/ 0 w 1992076"/>
              <a:gd name="connsiteY3" fmla="*/ 643834 h 81319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992076" h="813190">
                <a:moveTo>
                  <a:pt x="56329" y="0"/>
                </a:moveTo>
                <a:lnTo>
                  <a:pt x="1992076" y="169356"/>
                </a:lnTo>
                <a:lnTo>
                  <a:pt x="1935748" y="813190"/>
                </a:lnTo>
                <a:lnTo>
                  <a:pt x="0" y="643834"/>
                </a:lnTo>
                <a:close/>
              </a:path>
            </a:pathLst>
          </a:custGeom>
        </p:spPr>
      </p:pic>
      <p:sp>
        <p:nvSpPr>
          <p:cNvPr id="40" name="文本框 39">
            <a:extLst>
              <a:ext uri="{FF2B5EF4-FFF2-40B4-BE49-F238E27FC236}">
                <a16:creationId xmlns:a16="http://schemas.microsoft.com/office/drawing/2014/main" id="{A7059BA2-83E9-5AA5-C603-B1A101A58CCA}"/>
              </a:ext>
            </a:extLst>
          </p:cNvPr>
          <p:cNvSpPr txBox="1"/>
          <p:nvPr/>
        </p:nvSpPr>
        <p:spPr>
          <a:xfrm>
            <a:off x="3892731" y="8417520"/>
            <a:ext cx="6601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M</a:t>
            </a:r>
            <a:endParaRPr lang="zh-CN" altLang="en-US" sz="1200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1B06FDEE-07F9-F30B-F5CB-AEF90E5BDE74}"/>
              </a:ext>
            </a:extLst>
          </p:cNvPr>
          <p:cNvSpPr txBox="1"/>
          <p:nvPr/>
        </p:nvSpPr>
        <p:spPr>
          <a:xfrm>
            <a:off x="3914931" y="9092237"/>
            <a:ext cx="6601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M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0422775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D9F68CCC-8929-D8A2-C088-3A0A471A85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77" t="39566" r="20870" b="46992"/>
          <a:stretch>
            <a:fillRect/>
          </a:stretch>
        </p:blipFill>
        <p:spPr>
          <a:xfrm rot="-120000">
            <a:off x="1176840" y="1938205"/>
            <a:ext cx="3659008" cy="754516"/>
          </a:xfrm>
          <a:custGeom>
            <a:avLst/>
            <a:gdLst>
              <a:gd name="connsiteX0" fmla="*/ 21913 w 3659008"/>
              <a:gd name="connsiteY0" fmla="*/ 0 h 754516"/>
              <a:gd name="connsiteX1" fmla="*/ 3659008 w 3659008"/>
              <a:gd name="connsiteY1" fmla="*/ 127010 h 754516"/>
              <a:gd name="connsiteX2" fmla="*/ 3637095 w 3659008"/>
              <a:gd name="connsiteY2" fmla="*/ 754516 h 754516"/>
              <a:gd name="connsiteX3" fmla="*/ 0 w 3659008"/>
              <a:gd name="connsiteY3" fmla="*/ 627506 h 75451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659008" h="754516">
                <a:moveTo>
                  <a:pt x="21913" y="0"/>
                </a:moveTo>
                <a:lnTo>
                  <a:pt x="3659008" y="127010"/>
                </a:lnTo>
                <a:lnTo>
                  <a:pt x="3637095" y="754516"/>
                </a:lnTo>
                <a:lnTo>
                  <a:pt x="0" y="627506"/>
                </a:lnTo>
                <a:close/>
              </a:path>
            </a:pathLst>
          </a:cu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9869E9DB-5DAC-80AE-742A-5FEC54DA978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17" t="36806" r="20357" b="47925"/>
          <a:stretch>
            <a:fillRect/>
          </a:stretch>
        </p:blipFill>
        <p:spPr>
          <a:xfrm rot="-60000">
            <a:off x="1172073" y="2687597"/>
            <a:ext cx="3830637" cy="868376"/>
          </a:xfrm>
          <a:custGeom>
            <a:avLst/>
            <a:gdLst>
              <a:gd name="connsiteX0" fmla="*/ 13812 w 3780566"/>
              <a:gd name="connsiteY0" fmla="*/ 0 h 857025"/>
              <a:gd name="connsiteX1" fmla="*/ 3780566 w 3780566"/>
              <a:gd name="connsiteY1" fmla="*/ 65749 h 857025"/>
              <a:gd name="connsiteX2" fmla="*/ 3766754 w 3780566"/>
              <a:gd name="connsiteY2" fmla="*/ 857025 h 857025"/>
              <a:gd name="connsiteX3" fmla="*/ 0 w 3780566"/>
              <a:gd name="connsiteY3" fmla="*/ 791276 h 8570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3780566" h="857025">
                <a:moveTo>
                  <a:pt x="13812" y="0"/>
                </a:moveTo>
                <a:lnTo>
                  <a:pt x="3780566" y="65749"/>
                </a:lnTo>
                <a:lnTo>
                  <a:pt x="3766754" y="857025"/>
                </a:lnTo>
                <a:lnTo>
                  <a:pt x="0" y="791276"/>
                </a:lnTo>
                <a:close/>
              </a:path>
            </a:pathLst>
          </a:cu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C8DE86E1-809E-C4F7-9358-33FA0660210D}"/>
              </a:ext>
            </a:extLst>
          </p:cNvPr>
          <p:cNvSpPr txBox="1"/>
          <p:nvPr/>
        </p:nvSpPr>
        <p:spPr>
          <a:xfrm>
            <a:off x="637488" y="2152580"/>
            <a:ext cx="5344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Actin</a:t>
            </a:r>
            <a:endParaRPr lang="zh-CN" altLang="en-US" sz="12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65DF07A6-4C8B-CD3C-6A95-52CB949DEEE8}"/>
              </a:ext>
            </a:extLst>
          </p:cNvPr>
          <p:cNvSpPr txBox="1"/>
          <p:nvPr/>
        </p:nvSpPr>
        <p:spPr>
          <a:xfrm>
            <a:off x="232013" y="2861352"/>
            <a:ext cx="8789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Integrin β3</a:t>
            </a:r>
            <a:endParaRPr lang="zh-CN" altLang="en-US" sz="12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D911FA7-0E2B-3959-439B-1E5AE67D8F4D}"/>
              </a:ext>
            </a:extLst>
          </p:cNvPr>
          <p:cNvSpPr txBox="1"/>
          <p:nvPr/>
        </p:nvSpPr>
        <p:spPr>
          <a:xfrm>
            <a:off x="1110940" y="1675012"/>
            <a:ext cx="34645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OVCA429  A2780   HUVEC      ID8      IOSE80   SKOV3</a:t>
            </a:r>
            <a:endParaRPr lang="zh-CN" altLang="en-US" sz="12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25593B1-346C-E5B0-CDFA-E6952E259334}"/>
              </a:ext>
            </a:extLst>
          </p:cNvPr>
          <p:cNvSpPr txBox="1"/>
          <p:nvPr/>
        </p:nvSpPr>
        <p:spPr>
          <a:xfrm>
            <a:off x="4607895" y="2040708"/>
            <a:ext cx="5344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M</a:t>
            </a:r>
            <a:endParaRPr lang="zh-CN" altLang="en-US" sz="12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1E26638-F146-64D7-5071-83792058A336}"/>
              </a:ext>
            </a:extLst>
          </p:cNvPr>
          <p:cNvSpPr txBox="1"/>
          <p:nvPr/>
        </p:nvSpPr>
        <p:spPr>
          <a:xfrm>
            <a:off x="4735676" y="2881432"/>
            <a:ext cx="5344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M</a:t>
            </a:r>
            <a:endParaRPr lang="zh-CN" altLang="en-US" sz="1200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FD10773E-F166-E345-9713-6D70186BC7B6}"/>
              </a:ext>
            </a:extLst>
          </p:cNvPr>
          <p:cNvSpPr txBox="1"/>
          <p:nvPr/>
        </p:nvSpPr>
        <p:spPr>
          <a:xfrm>
            <a:off x="1837777" y="1180588"/>
            <a:ext cx="34323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100" dirty="0">
                <a:effectLst/>
                <a:ea typeface="宋体" panose="02010600030101010101" pitchFamily="2" charset="-122"/>
              </a:rPr>
              <a:t>supplementary Fig.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8911674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9</TotalTime>
  <Words>50</Words>
  <Application>Microsoft Office PowerPoint</Application>
  <PresentationFormat>A4 纸张(210x297 毫米)</PresentationFormat>
  <Paragraphs>3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欣梅</dc:creator>
  <cp:lastModifiedBy>Zhang Qingyu</cp:lastModifiedBy>
  <cp:revision>49</cp:revision>
  <dcterms:created xsi:type="dcterms:W3CDTF">2022-10-25T12:23:52Z</dcterms:created>
  <dcterms:modified xsi:type="dcterms:W3CDTF">2023-03-02T12:35:57Z</dcterms:modified>
</cp:coreProperties>
</file>